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200" d="100"/>
          <a:sy n="200" d="100"/>
        </p:scale>
        <p:origin x="115" y="-39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818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881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298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78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683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136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731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698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248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165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829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CE669-3E29-4D3A-82BA-B9026CE4DB0C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3966E-0C54-4121-8C9B-0EA003642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359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0FC82858-9873-44FD-B8E4-B14FB58733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060" y="6165988"/>
            <a:ext cx="3642453" cy="336093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7135667-9022-4D48-893E-42EA50C06DC2}"/>
              </a:ext>
            </a:extLst>
          </p:cNvPr>
          <p:cNvSpPr txBox="1"/>
          <p:nvPr/>
        </p:nvSpPr>
        <p:spPr>
          <a:xfrm rot="18407606">
            <a:off x="966227" y="1333044"/>
            <a:ext cx="1160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1AE2A5-C162-4830-B602-15F703E1D73F}"/>
              </a:ext>
            </a:extLst>
          </p:cNvPr>
          <p:cNvSpPr txBox="1"/>
          <p:nvPr/>
        </p:nvSpPr>
        <p:spPr>
          <a:xfrm rot="18407606">
            <a:off x="1178106" y="974600"/>
            <a:ext cx="2047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0CAAA2-B3AF-4A34-B30D-EA9F44812933}"/>
              </a:ext>
            </a:extLst>
          </p:cNvPr>
          <p:cNvSpPr txBox="1"/>
          <p:nvPr/>
        </p:nvSpPr>
        <p:spPr>
          <a:xfrm rot="18407606">
            <a:off x="1633996" y="1162154"/>
            <a:ext cx="1627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B390C4C-4B6B-472B-AE6C-0DE7F395C3FE}"/>
              </a:ext>
            </a:extLst>
          </p:cNvPr>
          <p:cNvSpPr txBox="1"/>
          <p:nvPr/>
        </p:nvSpPr>
        <p:spPr>
          <a:xfrm rot="18407606">
            <a:off x="2210208" y="1447694"/>
            <a:ext cx="892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NL4-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0EC5710-1133-4964-8EB0-BAF8DCB4A7AE}"/>
              </a:ext>
            </a:extLst>
          </p:cNvPr>
          <p:cNvSpPr txBox="1"/>
          <p:nvPr/>
        </p:nvSpPr>
        <p:spPr>
          <a:xfrm rot="18407606">
            <a:off x="2359853" y="977758"/>
            <a:ext cx="2072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D1542CF-0E8A-4607-8A54-B9A944460AA3}"/>
              </a:ext>
            </a:extLst>
          </p:cNvPr>
          <p:cNvSpPr txBox="1"/>
          <p:nvPr/>
        </p:nvSpPr>
        <p:spPr>
          <a:xfrm rot="18407606">
            <a:off x="2944461" y="1144779"/>
            <a:ext cx="1641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ADEB5ED-9B86-4FBC-842A-CDC9E060048E}"/>
              </a:ext>
            </a:extLst>
          </p:cNvPr>
          <p:cNvSpPr txBox="1"/>
          <p:nvPr/>
        </p:nvSpPr>
        <p:spPr>
          <a:xfrm rot="18407606">
            <a:off x="3492033" y="1426429"/>
            <a:ext cx="9133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NL4-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BFCF1B4-469E-4E9C-A8D5-714AFA31977A}"/>
              </a:ext>
            </a:extLst>
          </p:cNvPr>
          <p:cNvSpPr txBox="1"/>
          <p:nvPr/>
        </p:nvSpPr>
        <p:spPr>
          <a:xfrm rot="18407606">
            <a:off x="3871248" y="1348435"/>
            <a:ext cx="1108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8EB642F-2625-4941-8CFD-63E013F694EE}"/>
              </a:ext>
            </a:extLst>
          </p:cNvPr>
          <p:cNvSpPr txBox="1"/>
          <p:nvPr/>
        </p:nvSpPr>
        <p:spPr>
          <a:xfrm>
            <a:off x="1066828" y="4429776"/>
            <a:ext cx="15456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dium prior to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ltracentrifugation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0BB9947-C6A0-4528-ADAA-1A24AE4F2CE4}"/>
              </a:ext>
            </a:extLst>
          </p:cNvPr>
          <p:cNvCxnSpPr/>
          <p:nvPr/>
        </p:nvCxnSpPr>
        <p:spPr>
          <a:xfrm>
            <a:off x="1014241" y="4416231"/>
            <a:ext cx="166834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B777ED40-5A11-4442-B185-37BEB6E24231}"/>
              </a:ext>
            </a:extLst>
          </p:cNvPr>
          <p:cNvSpPr txBox="1"/>
          <p:nvPr/>
        </p:nvSpPr>
        <p:spPr>
          <a:xfrm>
            <a:off x="2818071" y="4431711"/>
            <a:ext cx="15456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ellet after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ltracentrifugation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E8BC53C-6382-47C7-A375-6062148DA8F4}"/>
              </a:ext>
            </a:extLst>
          </p:cNvPr>
          <p:cNvCxnSpPr/>
          <p:nvPr/>
        </p:nvCxnSpPr>
        <p:spPr>
          <a:xfrm>
            <a:off x="2766602" y="4416231"/>
            <a:ext cx="166834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719132D3-44E5-4151-9B34-E08E9FFC2B3A}"/>
              </a:ext>
            </a:extLst>
          </p:cNvPr>
          <p:cNvSpPr txBox="1"/>
          <p:nvPr/>
        </p:nvSpPr>
        <p:spPr>
          <a:xfrm>
            <a:off x="1064709" y="9117761"/>
            <a:ext cx="15456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dium prior to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ltracentrifugatio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1E56006-724D-4D0C-9B2B-EAD8A5928BDB}"/>
              </a:ext>
            </a:extLst>
          </p:cNvPr>
          <p:cNvSpPr txBox="1"/>
          <p:nvPr/>
        </p:nvSpPr>
        <p:spPr>
          <a:xfrm>
            <a:off x="2753997" y="9112890"/>
            <a:ext cx="154561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ellet after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ltracentrifugation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58325516-EAB7-43E2-B503-AC13BEC20F7F}"/>
              </a:ext>
            </a:extLst>
          </p:cNvPr>
          <p:cNvCxnSpPr>
            <a:cxnSpLocks/>
          </p:cNvCxnSpPr>
          <p:nvPr/>
        </p:nvCxnSpPr>
        <p:spPr>
          <a:xfrm>
            <a:off x="2843082" y="9146574"/>
            <a:ext cx="12658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17DE20BD-3C86-4929-9E8E-F68A85C69491}"/>
              </a:ext>
            </a:extLst>
          </p:cNvPr>
          <p:cNvCxnSpPr>
            <a:cxnSpLocks/>
          </p:cNvCxnSpPr>
          <p:nvPr/>
        </p:nvCxnSpPr>
        <p:spPr>
          <a:xfrm>
            <a:off x="1003872" y="9146574"/>
            <a:ext cx="181463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69B7959F-91F7-49A2-9533-6F4B5D76DD23}"/>
              </a:ext>
            </a:extLst>
          </p:cNvPr>
          <p:cNvSpPr txBox="1"/>
          <p:nvPr/>
        </p:nvSpPr>
        <p:spPr>
          <a:xfrm rot="18407606">
            <a:off x="1047163" y="5915256"/>
            <a:ext cx="1101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F93AC9F-7CB6-4BB7-87A0-6B50A80E3793}"/>
              </a:ext>
            </a:extLst>
          </p:cNvPr>
          <p:cNvSpPr txBox="1"/>
          <p:nvPr/>
        </p:nvSpPr>
        <p:spPr>
          <a:xfrm rot="18407606">
            <a:off x="1236724" y="5563136"/>
            <a:ext cx="1986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B3E0C3C-DAC8-4036-AC30-739B6EC1ACAD}"/>
              </a:ext>
            </a:extLst>
          </p:cNvPr>
          <p:cNvSpPr txBox="1"/>
          <p:nvPr/>
        </p:nvSpPr>
        <p:spPr>
          <a:xfrm rot="18407606">
            <a:off x="1802855" y="5709360"/>
            <a:ext cx="1571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C708D02-E6F2-4FBC-8140-E9BA01F93D01}"/>
              </a:ext>
            </a:extLst>
          </p:cNvPr>
          <p:cNvSpPr txBox="1"/>
          <p:nvPr/>
        </p:nvSpPr>
        <p:spPr>
          <a:xfrm rot="18407606">
            <a:off x="2370732" y="5999082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NL4-3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7343FCA-866F-4E49-B0FE-A493A51FC68B}"/>
              </a:ext>
            </a:extLst>
          </p:cNvPr>
          <p:cNvSpPr txBox="1"/>
          <p:nvPr/>
        </p:nvSpPr>
        <p:spPr>
          <a:xfrm rot="18407606">
            <a:off x="2564834" y="5556171"/>
            <a:ext cx="1998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0906307-E58D-41F4-98B1-0BBC43F8E130}"/>
              </a:ext>
            </a:extLst>
          </p:cNvPr>
          <p:cNvSpPr txBox="1"/>
          <p:nvPr/>
        </p:nvSpPr>
        <p:spPr>
          <a:xfrm rot="18407606">
            <a:off x="3035994" y="5728314"/>
            <a:ext cx="1571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35AE9C0-6374-4025-AB5A-323D31474413}"/>
              </a:ext>
            </a:extLst>
          </p:cNvPr>
          <p:cNvSpPr txBox="1"/>
          <p:nvPr/>
        </p:nvSpPr>
        <p:spPr>
          <a:xfrm rot="18407606">
            <a:off x="3586677" y="602187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NL4-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7EA44CE-B8BF-40BF-9B94-1AF3F4A2DD11}"/>
              </a:ext>
            </a:extLst>
          </p:cNvPr>
          <p:cNvSpPr txBox="1"/>
          <p:nvPr/>
        </p:nvSpPr>
        <p:spPr>
          <a:xfrm>
            <a:off x="380153" y="191469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26F0D15-BA4D-4ABC-B97C-914FBE11E005}"/>
              </a:ext>
            </a:extLst>
          </p:cNvPr>
          <p:cNvSpPr txBox="1"/>
          <p:nvPr/>
        </p:nvSpPr>
        <p:spPr>
          <a:xfrm>
            <a:off x="390281" y="229276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C00465D-6824-4EFD-9396-E41F413C3588}"/>
              </a:ext>
            </a:extLst>
          </p:cNvPr>
          <p:cNvSpPr txBox="1"/>
          <p:nvPr/>
        </p:nvSpPr>
        <p:spPr>
          <a:xfrm>
            <a:off x="390281" y="265122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4944FDF-6E7D-41B9-B120-C7E23C334719}"/>
              </a:ext>
            </a:extLst>
          </p:cNvPr>
          <p:cNvSpPr txBox="1"/>
          <p:nvPr/>
        </p:nvSpPr>
        <p:spPr>
          <a:xfrm>
            <a:off x="479539" y="294615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FD6AE6A-783D-4070-85D2-4E6E7422351E}"/>
              </a:ext>
            </a:extLst>
          </p:cNvPr>
          <p:cNvSpPr txBox="1"/>
          <p:nvPr/>
        </p:nvSpPr>
        <p:spPr>
          <a:xfrm>
            <a:off x="479558" y="335698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57284BE-49DF-4BF2-AA74-79451068159D}"/>
              </a:ext>
            </a:extLst>
          </p:cNvPr>
          <p:cNvSpPr txBox="1"/>
          <p:nvPr/>
        </p:nvSpPr>
        <p:spPr>
          <a:xfrm>
            <a:off x="479558" y="381535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B01E5358-C91A-401B-B9BD-49CE2E63284D}"/>
              </a:ext>
            </a:extLst>
          </p:cNvPr>
          <p:cNvCxnSpPr/>
          <p:nvPr/>
        </p:nvCxnSpPr>
        <p:spPr>
          <a:xfrm>
            <a:off x="4154376" y="7190538"/>
            <a:ext cx="218748" cy="0"/>
          </a:xfrm>
          <a:prstGeom prst="line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6B52EDAE-ACFF-418F-A507-B92B2398EA39}"/>
              </a:ext>
            </a:extLst>
          </p:cNvPr>
          <p:cNvCxnSpPr/>
          <p:nvPr/>
        </p:nvCxnSpPr>
        <p:spPr>
          <a:xfrm>
            <a:off x="4162347" y="8798357"/>
            <a:ext cx="218748" cy="0"/>
          </a:xfrm>
          <a:prstGeom prst="line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7C7FB930-D673-43B1-80EE-BD014370DFDB}"/>
              </a:ext>
            </a:extLst>
          </p:cNvPr>
          <p:cNvCxnSpPr>
            <a:cxnSpLocks/>
          </p:cNvCxnSpPr>
          <p:nvPr/>
        </p:nvCxnSpPr>
        <p:spPr>
          <a:xfrm>
            <a:off x="850598" y="8689356"/>
            <a:ext cx="1532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D95B939D-CE9A-468E-8656-3D7B641D3294}"/>
              </a:ext>
            </a:extLst>
          </p:cNvPr>
          <p:cNvSpPr txBox="1"/>
          <p:nvPr/>
        </p:nvSpPr>
        <p:spPr>
          <a:xfrm>
            <a:off x="415345" y="685495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64F925D0-D8D6-4B58-AA9F-A0C69FC642D9}"/>
              </a:ext>
            </a:extLst>
          </p:cNvPr>
          <p:cNvSpPr txBox="1"/>
          <p:nvPr/>
        </p:nvSpPr>
        <p:spPr>
          <a:xfrm>
            <a:off x="430772" y="721746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63245BFA-D964-49F1-BFCA-9F37C309475C}"/>
              </a:ext>
            </a:extLst>
          </p:cNvPr>
          <p:cNvSpPr txBox="1"/>
          <p:nvPr/>
        </p:nvSpPr>
        <p:spPr>
          <a:xfrm>
            <a:off x="519382" y="752126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4BB7579-1FC7-466D-8A2E-A74447945FE1}"/>
              </a:ext>
            </a:extLst>
          </p:cNvPr>
          <p:cNvSpPr txBox="1"/>
          <p:nvPr/>
        </p:nvSpPr>
        <p:spPr>
          <a:xfrm>
            <a:off x="524046" y="785766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5DABE4B-3585-429A-B734-E9B16412E7D9}"/>
              </a:ext>
            </a:extLst>
          </p:cNvPr>
          <p:cNvSpPr txBox="1"/>
          <p:nvPr/>
        </p:nvSpPr>
        <p:spPr>
          <a:xfrm>
            <a:off x="532831" y="816390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67D322A-FC60-46DC-B17D-6D5DB8D3CF5E}"/>
              </a:ext>
            </a:extLst>
          </p:cNvPr>
          <p:cNvSpPr txBox="1"/>
          <p:nvPr/>
        </p:nvSpPr>
        <p:spPr>
          <a:xfrm>
            <a:off x="524221" y="852250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4D957C66-CC58-4473-8134-BDB3FFB30D1A}"/>
              </a:ext>
            </a:extLst>
          </p:cNvPr>
          <p:cNvCxnSpPr>
            <a:cxnSpLocks/>
          </p:cNvCxnSpPr>
          <p:nvPr/>
        </p:nvCxnSpPr>
        <p:spPr>
          <a:xfrm>
            <a:off x="839843" y="7659167"/>
            <a:ext cx="1532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B470A8C1-6609-4F89-AFAF-D5276E62A32E}"/>
              </a:ext>
            </a:extLst>
          </p:cNvPr>
          <p:cNvCxnSpPr>
            <a:cxnSpLocks/>
          </p:cNvCxnSpPr>
          <p:nvPr/>
        </p:nvCxnSpPr>
        <p:spPr>
          <a:xfrm>
            <a:off x="839843" y="7375738"/>
            <a:ext cx="1532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48BAF7F1-A9CA-4ADB-8839-D2F08229A41C}"/>
              </a:ext>
            </a:extLst>
          </p:cNvPr>
          <p:cNvCxnSpPr>
            <a:cxnSpLocks/>
          </p:cNvCxnSpPr>
          <p:nvPr/>
        </p:nvCxnSpPr>
        <p:spPr>
          <a:xfrm>
            <a:off x="839843" y="7004680"/>
            <a:ext cx="1532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0E68E9C3-A5D8-484D-A5A9-B48A310229FC}"/>
              </a:ext>
            </a:extLst>
          </p:cNvPr>
          <p:cNvCxnSpPr>
            <a:cxnSpLocks/>
          </p:cNvCxnSpPr>
          <p:nvPr/>
        </p:nvCxnSpPr>
        <p:spPr>
          <a:xfrm>
            <a:off x="850480" y="8004263"/>
            <a:ext cx="1532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5711F667-C03C-41F6-89D1-5BF792A913FE}"/>
              </a:ext>
            </a:extLst>
          </p:cNvPr>
          <p:cNvCxnSpPr>
            <a:cxnSpLocks/>
          </p:cNvCxnSpPr>
          <p:nvPr/>
        </p:nvCxnSpPr>
        <p:spPr>
          <a:xfrm>
            <a:off x="850598" y="8312074"/>
            <a:ext cx="1532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B9046238-AE7D-427D-ABC2-3E1074056A3E}"/>
              </a:ext>
            </a:extLst>
          </p:cNvPr>
          <p:cNvCxnSpPr>
            <a:cxnSpLocks/>
          </p:cNvCxnSpPr>
          <p:nvPr/>
        </p:nvCxnSpPr>
        <p:spPr>
          <a:xfrm>
            <a:off x="812181" y="3947393"/>
            <a:ext cx="15327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8457FDFC-E0F8-467C-A37E-A203E69D9A7D}"/>
              </a:ext>
            </a:extLst>
          </p:cNvPr>
          <p:cNvSpPr txBox="1"/>
          <p:nvPr/>
        </p:nvSpPr>
        <p:spPr>
          <a:xfrm>
            <a:off x="558563" y="138504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7AFC4D9B-1D37-49C8-AFCC-9831F29DF366}"/>
              </a:ext>
            </a:extLst>
          </p:cNvPr>
          <p:cNvSpPr txBox="1"/>
          <p:nvPr/>
        </p:nvSpPr>
        <p:spPr>
          <a:xfrm>
            <a:off x="540207" y="604389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5F9ECA7-A73A-41AB-AE5E-5B8D9736FD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76733" y="1854751"/>
            <a:ext cx="2146517" cy="278020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722D9AA-EB2B-443E-867B-8659647AB9B0}"/>
              </a:ext>
            </a:extLst>
          </p:cNvPr>
          <p:cNvSpPr txBox="1"/>
          <p:nvPr/>
        </p:nvSpPr>
        <p:spPr>
          <a:xfrm rot="18407606">
            <a:off x="5230500" y="943867"/>
            <a:ext cx="2102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9475422-044B-46E1-8405-B5D58AB01FD5}"/>
              </a:ext>
            </a:extLst>
          </p:cNvPr>
          <p:cNvSpPr txBox="1"/>
          <p:nvPr/>
        </p:nvSpPr>
        <p:spPr>
          <a:xfrm rot="18407606">
            <a:off x="5681477" y="1147690"/>
            <a:ext cx="16248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8659ED8-9917-432C-A673-CFEA2E377A93}"/>
              </a:ext>
            </a:extLst>
          </p:cNvPr>
          <p:cNvSpPr txBox="1"/>
          <p:nvPr/>
        </p:nvSpPr>
        <p:spPr>
          <a:xfrm rot="18407606">
            <a:off x="6162978" y="1446237"/>
            <a:ext cx="888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NL4-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F1A10B0-8892-4980-B85A-0C54B2786DE8}"/>
              </a:ext>
            </a:extLst>
          </p:cNvPr>
          <p:cNvSpPr txBox="1"/>
          <p:nvPr/>
        </p:nvSpPr>
        <p:spPr>
          <a:xfrm rot="18407606">
            <a:off x="6521828" y="1351509"/>
            <a:ext cx="1139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609192B-EC18-4314-93D6-C7CC1CECC084}"/>
              </a:ext>
            </a:extLst>
          </p:cNvPr>
          <p:cNvSpPr txBox="1"/>
          <p:nvPr/>
        </p:nvSpPr>
        <p:spPr>
          <a:xfrm>
            <a:off x="5788898" y="4490404"/>
            <a:ext cx="1210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E4E7817-9C38-4730-86D3-2778E2A5F9F2}"/>
              </a:ext>
            </a:extLst>
          </p:cNvPr>
          <p:cNvCxnSpPr>
            <a:cxnSpLocks/>
          </p:cNvCxnSpPr>
          <p:nvPr/>
        </p:nvCxnSpPr>
        <p:spPr>
          <a:xfrm>
            <a:off x="5662430" y="4446722"/>
            <a:ext cx="139466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6261FD56-A000-4F46-A150-B8DF9C8B428D}"/>
              </a:ext>
            </a:extLst>
          </p:cNvPr>
          <p:cNvCxnSpPr>
            <a:cxnSpLocks/>
          </p:cNvCxnSpPr>
          <p:nvPr/>
        </p:nvCxnSpPr>
        <p:spPr>
          <a:xfrm>
            <a:off x="5379017" y="4056210"/>
            <a:ext cx="1408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2EC2B234-3B4E-423E-A7F4-E5CA974E9902}"/>
              </a:ext>
            </a:extLst>
          </p:cNvPr>
          <p:cNvCxnSpPr>
            <a:cxnSpLocks/>
          </p:cNvCxnSpPr>
          <p:nvPr/>
        </p:nvCxnSpPr>
        <p:spPr>
          <a:xfrm>
            <a:off x="7091408" y="2531444"/>
            <a:ext cx="182863" cy="0"/>
          </a:xfrm>
          <a:prstGeom prst="line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8B1D1370-AF5A-4484-B1E6-B2AC73DD1270}"/>
              </a:ext>
            </a:extLst>
          </p:cNvPr>
          <p:cNvCxnSpPr>
            <a:cxnSpLocks/>
          </p:cNvCxnSpPr>
          <p:nvPr/>
        </p:nvCxnSpPr>
        <p:spPr>
          <a:xfrm>
            <a:off x="7113070" y="3820054"/>
            <a:ext cx="182863" cy="0"/>
          </a:xfrm>
          <a:prstGeom prst="line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CF78F16A-EED2-4FEC-95A0-A5B54D3F435D}"/>
              </a:ext>
            </a:extLst>
          </p:cNvPr>
          <p:cNvSpPr txBox="1"/>
          <p:nvPr/>
        </p:nvSpPr>
        <p:spPr>
          <a:xfrm>
            <a:off x="4976324" y="2005182"/>
            <a:ext cx="453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FE929491-9EA3-4338-966E-8A5B309A97E4}"/>
              </a:ext>
            </a:extLst>
          </p:cNvPr>
          <p:cNvSpPr txBox="1"/>
          <p:nvPr/>
        </p:nvSpPr>
        <p:spPr>
          <a:xfrm>
            <a:off x="4958772" y="2375408"/>
            <a:ext cx="453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9B7FAFDB-474D-431A-92FC-9D40AF771D12}"/>
              </a:ext>
            </a:extLst>
          </p:cNvPr>
          <p:cNvSpPr txBox="1"/>
          <p:nvPr/>
        </p:nvSpPr>
        <p:spPr>
          <a:xfrm>
            <a:off x="4958772" y="2742320"/>
            <a:ext cx="4712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BB84B7B-0A4C-41B9-A4AA-A2429913E382}"/>
              </a:ext>
            </a:extLst>
          </p:cNvPr>
          <p:cNvSpPr txBox="1"/>
          <p:nvPr/>
        </p:nvSpPr>
        <p:spPr>
          <a:xfrm>
            <a:off x="5051215" y="3053280"/>
            <a:ext cx="378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76FD62DE-1E96-43C6-9A19-020473CC5049}"/>
              </a:ext>
            </a:extLst>
          </p:cNvPr>
          <p:cNvSpPr txBox="1"/>
          <p:nvPr/>
        </p:nvSpPr>
        <p:spPr>
          <a:xfrm>
            <a:off x="5058470" y="3440898"/>
            <a:ext cx="3715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C407C331-BEA6-483E-8266-2FF2291201AF}"/>
              </a:ext>
            </a:extLst>
          </p:cNvPr>
          <p:cNvSpPr txBox="1"/>
          <p:nvPr/>
        </p:nvSpPr>
        <p:spPr>
          <a:xfrm>
            <a:off x="5066088" y="3911296"/>
            <a:ext cx="4752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1136DA20-F8DA-4E52-A945-19A52B1D0C0C}"/>
              </a:ext>
            </a:extLst>
          </p:cNvPr>
          <p:cNvCxnSpPr>
            <a:cxnSpLocks/>
          </p:cNvCxnSpPr>
          <p:nvPr/>
        </p:nvCxnSpPr>
        <p:spPr>
          <a:xfrm>
            <a:off x="5361869" y="3595234"/>
            <a:ext cx="1408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068B6F77-F895-4ACF-8408-18680E217544}"/>
              </a:ext>
            </a:extLst>
          </p:cNvPr>
          <p:cNvCxnSpPr>
            <a:cxnSpLocks/>
          </p:cNvCxnSpPr>
          <p:nvPr/>
        </p:nvCxnSpPr>
        <p:spPr>
          <a:xfrm>
            <a:off x="5350388" y="2531444"/>
            <a:ext cx="1408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587D8403-618D-4B01-A91E-B9400C305FF2}"/>
              </a:ext>
            </a:extLst>
          </p:cNvPr>
          <p:cNvCxnSpPr>
            <a:cxnSpLocks/>
          </p:cNvCxnSpPr>
          <p:nvPr/>
        </p:nvCxnSpPr>
        <p:spPr>
          <a:xfrm>
            <a:off x="5368262" y="3193358"/>
            <a:ext cx="1408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CCF7BED0-7627-4308-AD6C-B44E360C3510}"/>
              </a:ext>
            </a:extLst>
          </p:cNvPr>
          <p:cNvCxnSpPr>
            <a:cxnSpLocks/>
          </p:cNvCxnSpPr>
          <p:nvPr/>
        </p:nvCxnSpPr>
        <p:spPr>
          <a:xfrm>
            <a:off x="5361869" y="2897860"/>
            <a:ext cx="1408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0630BAE4-90F1-4FB7-A908-ED3F93DF1CE3}"/>
              </a:ext>
            </a:extLst>
          </p:cNvPr>
          <p:cNvCxnSpPr>
            <a:cxnSpLocks/>
          </p:cNvCxnSpPr>
          <p:nvPr/>
        </p:nvCxnSpPr>
        <p:spPr>
          <a:xfrm>
            <a:off x="5363777" y="2150808"/>
            <a:ext cx="1408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9C367EB8-1B2D-4247-A608-947B225D30DE}"/>
              </a:ext>
            </a:extLst>
          </p:cNvPr>
          <p:cNvSpPr txBox="1"/>
          <p:nvPr/>
        </p:nvSpPr>
        <p:spPr>
          <a:xfrm>
            <a:off x="5014509" y="1394468"/>
            <a:ext cx="415498" cy="3819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315B182-03CD-4892-9D4A-B2C627052F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18391" y="6401084"/>
            <a:ext cx="2069292" cy="2837969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1304C0DB-DE66-4C90-B383-0BB5F892D291}"/>
              </a:ext>
            </a:extLst>
          </p:cNvPr>
          <p:cNvSpPr txBox="1"/>
          <p:nvPr/>
        </p:nvSpPr>
        <p:spPr>
          <a:xfrm rot="18407606">
            <a:off x="5237863" y="5877662"/>
            <a:ext cx="1226598" cy="2598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EC8A3B7-5B9E-41D8-B756-5FB28922D3F0}"/>
              </a:ext>
            </a:extLst>
          </p:cNvPr>
          <p:cNvSpPr txBox="1"/>
          <p:nvPr/>
        </p:nvSpPr>
        <p:spPr>
          <a:xfrm rot="18407606">
            <a:off x="5826084" y="5695427"/>
            <a:ext cx="1583322" cy="2598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2D15B93-B767-42F2-B988-23999DFB6ED6}"/>
              </a:ext>
            </a:extLst>
          </p:cNvPr>
          <p:cNvSpPr txBox="1"/>
          <p:nvPr/>
        </p:nvSpPr>
        <p:spPr>
          <a:xfrm rot="18407606">
            <a:off x="6351013" y="5981981"/>
            <a:ext cx="891872" cy="2598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NL4-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22064C4-BB58-4F98-8724-8A1BCC549249}"/>
              </a:ext>
            </a:extLst>
          </p:cNvPr>
          <p:cNvSpPr txBox="1"/>
          <p:nvPr/>
        </p:nvSpPr>
        <p:spPr>
          <a:xfrm>
            <a:off x="5645712" y="9102827"/>
            <a:ext cx="10294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ell lysates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0BB0EEEA-F426-42F4-B149-43B5515B8D22}"/>
              </a:ext>
            </a:extLst>
          </p:cNvPr>
          <p:cNvCxnSpPr/>
          <p:nvPr/>
        </p:nvCxnSpPr>
        <p:spPr>
          <a:xfrm>
            <a:off x="5389628" y="9131204"/>
            <a:ext cx="156479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59E63740-3A2D-48CE-BFC2-5AF5DF84339C}"/>
              </a:ext>
            </a:extLst>
          </p:cNvPr>
          <p:cNvCxnSpPr/>
          <p:nvPr/>
        </p:nvCxnSpPr>
        <p:spPr>
          <a:xfrm>
            <a:off x="7010035" y="6981612"/>
            <a:ext cx="205171" cy="0"/>
          </a:xfrm>
          <a:prstGeom prst="line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3601ECA3-F159-4DCF-BBE7-ADF2C1F97B8E}"/>
              </a:ext>
            </a:extLst>
          </p:cNvPr>
          <p:cNvCxnSpPr/>
          <p:nvPr/>
        </p:nvCxnSpPr>
        <p:spPr>
          <a:xfrm>
            <a:off x="6998991" y="7172111"/>
            <a:ext cx="205171" cy="0"/>
          </a:xfrm>
          <a:prstGeom prst="line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280D22BB-BCB1-4496-B5D9-CD7A1455DDC2}"/>
              </a:ext>
            </a:extLst>
          </p:cNvPr>
          <p:cNvSpPr txBox="1"/>
          <p:nvPr/>
        </p:nvSpPr>
        <p:spPr>
          <a:xfrm>
            <a:off x="4814125" y="649516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F62A20AB-99BA-4897-8871-12ACA9B6A2E3}"/>
              </a:ext>
            </a:extLst>
          </p:cNvPr>
          <p:cNvSpPr txBox="1"/>
          <p:nvPr/>
        </p:nvSpPr>
        <p:spPr>
          <a:xfrm>
            <a:off x="4830190" y="689999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E04E045-6206-42AD-87B8-A7A9F1073D03}"/>
              </a:ext>
            </a:extLst>
          </p:cNvPr>
          <p:cNvSpPr txBox="1"/>
          <p:nvPr/>
        </p:nvSpPr>
        <p:spPr>
          <a:xfrm>
            <a:off x="4830190" y="720440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6AD145F-4BE6-4AF0-831A-6EBAEEB14F8C}"/>
              </a:ext>
            </a:extLst>
          </p:cNvPr>
          <p:cNvSpPr txBox="1"/>
          <p:nvPr/>
        </p:nvSpPr>
        <p:spPr>
          <a:xfrm>
            <a:off x="4885527" y="762387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1F9D115-E125-4BF9-8706-F0865DCC1872}"/>
              </a:ext>
            </a:extLst>
          </p:cNvPr>
          <p:cNvSpPr txBox="1"/>
          <p:nvPr/>
        </p:nvSpPr>
        <p:spPr>
          <a:xfrm>
            <a:off x="4911047" y="79858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3F9DF01-3F89-456C-B1C4-60552A51BAD5}"/>
              </a:ext>
            </a:extLst>
          </p:cNvPr>
          <p:cNvSpPr txBox="1"/>
          <p:nvPr/>
        </p:nvSpPr>
        <p:spPr>
          <a:xfrm>
            <a:off x="4923407" y="82508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45C3CF2-8E14-4A5E-87B3-A475A9066ECA}"/>
              </a:ext>
            </a:extLst>
          </p:cNvPr>
          <p:cNvSpPr txBox="1"/>
          <p:nvPr/>
        </p:nvSpPr>
        <p:spPr>
          <a:xfrm>
            <a:off x="4911391" y="86260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7C54B3D6-66EA-4541-8C66-A7DFD68372ED}"/>
              </a:ext>
            </a:extLst>
          </p:cNvPr>
          <p:cNvCxnSpPr/>
          <p:nvPr/>
        </p:nvCxnSpPr>
        <p:spPr>
          <a:xfrm>
            <a:off x="7010035" y="7936944"/>
            <a:ext cx="205171" cy="0"/>
          </a:xfrm>
          <a:prstGeom prst="line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B86BE1BE-EAFE-43F5-9EDF-A662CD74B7CB}"/>
              </a:ext>
            </a:extLst>
          </p:cNvPr>
          <p:cNvCxnSpPr>
            <a:cxnSpLocks/>
          </p:cNvCxnSpPr>
          <p:nvPr/>
        </p:nvCxnSpPr>
        <p:spPr>
          <a:xfrm>
            <a:off x="7025717" y="8804233"/>
            <a:ext cx="274838" cy="0"/>
          </a:xfrm>
          <a:prstGeom prst="line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A7F5A25C-556B-4AA6-A99C-F1C02F1778FE}"/>
              </a:ext>
            </a:extLst>
          </p:cNvPr>
          <p:cNvSpPr txBox="1"/>
          <p:nvPr/>
        </p:nvSpPr>
        <p:spPr>
          <a:xfrm>
            <a:off x="4900542" y="5923377"/>
            <a:ext cx="389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7BD6148F-C746-4D0D-94C1-EFDCCF0D8CC1}"/>
              </a:ext>
            </a:extLst>
          </p:cNvPr>
          <p:cNvCxnSpPr>
            <a:cxnSpLocks/>
          </p:cNvCxnSpPr>
          <p:nvPr/>
        </p:nvCxnSpPr>
        <p:spPr>
          <a:xfrm>
            <a:off x="5211166" y="8789447"/>
            <a:ext cx="14376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C71C752A-DB37-47CD-9550-97704D0662F9}"/>
              </a:ext>
            </a:extLst>
          </p:cNvPr>
          <p:cNvCxnSpPr>
            <a:cxnSpLocks/>
          </p:cNvCxnSpPr>
          <p:nvPr/>
        </p:nvCxnSpPr>
        <p:spPr>
          <a:xfrm>
            <a:off x="5221469" y="8412556"/>
            <a:ext cx="14376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340F543C-4356-4D54-B7CA-FE5FC511C9FA}"/>
              </a:ext>
            </a:extLst>
          </p:cNvPr>
          <p:cNvCxnSpPr>
            <a:cxnSpLocks/>
          </p:cNvCxnSpPr>
          <p:nvPr/>
        </p:nvCxnSpPr>
        <p:spPr>
          <a:xfrm>
            <a:off x="5201916" y="7795036"/>
            <a:ext cx="14376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993F3270-B713-47B2-9C6A-EBAB25CBBB10}"/>
              </a:ext>
            </a:extLst>
          </p:cNvPr>
          <p:cNvCxnSpPr>
            <a:cxnSpLocks/>
          </p:cNvCxnSpPr>
          <p:nvPr/>
        </p:nvCxnSpPr>
        <p:spPr>
          <a:xfrm>
            <a:off x="5229783" y="8139724"/>
            <a:ext cx="14376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17324D08-A8B8-45F5-A811-6B7B38B07822}"/>
              </a:ext>
            </a:extLst>
          </p:cNvPr>
          <p:cNvCxnSpPr>
            <a:cxnSpLocks/>
          </p:cNvCxnSpPr>
          <p:nvPr/>
        </p:nvCxnSpPr>
        <p:spPr>
          <a:xfrm>
            <a:off x="5218371" y="7071136"/>
            <a:ext cx="14376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90B1D3E3-5013-4102-A64E-182B3B5A80BB}"/>
              </a:ext>
            </a:extLst>
          </p:cNvPr>
          <p:cNvCxnSpPr>
            <a:cxnSpLocks/>
          </p:cNvCxnSpPr>
          <p:nvPr/>
        </p:nvCxnSpPr>
        <p:spPr>
          <a:xfrm>
            <a:off x="5218371" y="7351009"/>
            <a:ext cx="14376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93061278-E0DC-4A1F-99E5-998C680CC421}"/>
              </a:ext>
            </a:extLst>
          </p:cNvPr>
          <p:cNvCxnSpPr>
            <a:cxnSpLocks/>
          </p:cNvCxnSpPr>
          <p:nvPr/>
        </p:nvCxnSpPr>
        <p:spPr>
          <a:xfrm>
            <a:off x="5211166" y="6647816"/>
            <a:ext cx="14376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75997A05-8FD1-4AFD-A3C1-95B4CFD0DA49}"/>
              </a:ext>
            </a:extLst>
          </p:cNvPr>
          <p:cNvSpPr txBox="1"/>
          <p:nvPr/>
        </p:nvSpPr>
        <p:spPr>
          <a:xfrm>
            <a:off x="7196904" y="2374226"/>
            <a:ext cx="7414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p16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7EE2DDBF-EFFA-45EB-8F6E-40CC691C91E9}"/>
              </a:ext>
            </a:extLst>
          </p:cNvPr>
          <p:cNvSpPr txBox="1"/>
          <p:nvPr/>
        </p:nvSpPr>
        <p:spPr>
          <a:xfrm>
            <a:off x="7217994" y="3649580"/>
            <a:ext cx="7414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p4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CB07D24-71B7-4432-B91B-C6B124F5B1E7}"/>
              </a:ext>
            </a:extLst>
          </p:cNvPr>
          <p:cNvSpPr txBox="1"/>
          <p:nvPr/>
        </p:nvSpPr>
        <p:spPr>
          <a:xfrm rot="18407606">
            <a:off x="5338215" y="5525545"/>
            <a:ext cx="2078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DNA3.1(+)/NL4-3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CB614555-9D1F-4A1E-8DD2-B53675C606E2}"/>
              </a:ext>
            </a:extLst>
          </p:cNvPr>
          <p:cNvSpPr txBox="1"/>
          <p:nvPr/>
        </p:nvSpPr>
        <p:spPr>
          <a:xfrm>
            <a:off x="4542739" y="3554365"/>
            <a:ext cx="558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p41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670182BC-4627-46F7-ACC9-BE2C09FE4774}"/>
              </a:ext>
            </a:extLst>
          </p:cNvPr>
          <p:cNvSpPr txBox="1"/>
          <p:nvPr/>
        </p:nvSpPr>
        <p:spPr>
          <a:xfrm>
            <a:off x="4294705" y="7042075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p120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05022A35-0F3A-49DF-A25E-003E98EA3BF9}"/>
              </a:ext>
            </a:extLst>
          </p:cNvPr>
          <p:cNvSpPr txBox="1"/>
          <p:nvPr/>
        </p:nvSpPr>
        <p:spPr>
          <a:xfrm>
            <a:off x="4338608" y="865985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24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A661703E-DC8A-4C30-9033-3345F437EAFE}"/>
              </a:ext>
            </a:extLst>
          </p:cNvPr>
          <p:cNvSpPr txBox="1"/>
          <p:nvPr/>
        </p:nvSpPr>
        <p:spPr>
          <a:xfrm>
            <a:off x="7138742" y="7026522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p120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A9432E8B-0DD1-470E-B509-A2301F5CDDD1}"/>
              </a:ext>
            </a:extLst>
          </p:cNvPr>
          <p:cNvSpPr txBox="1"/>
          <p:nvPr/>
        </p:nvSpPr>
        <p:spPr>
          <a:xfrm>
            <a:off x="7161535" y="6813288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p160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A5731454-6BEB-4821-A4A7-651477CA70EF}"/>
              </a:ext>
            </a:extLst>
          </p:cNvPr>
          <p:cNvSpPr txBox="1"/>
          <p:nvPr/>
        </p:nvSpPr>
        <p:spPr>
          <a:xfrm>
            <a:off x="7170882" y="7790084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55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904AA542-F084-46AD-B286-A76590CF3A26}"/>
              </a:ext>
            </a:extLst>
          </p:cNvPr>
          <p:cNvSpPr txBox="1"/>
          <p:nvPr/>
        </p:nvSpPr>
        <p:spPr>
          <a:xfrm>
            <a:off x="7239410" y="865094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24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2B85F723-A361-486A-B553-F846F2EBE686}"/>
              </a:ext>
            </a:extLst>
          </p:cNvPr>
          <p:cNvGrpSpPr/>
          <p:nvPr/>
        </p:nvGrpSpPr>
        <p:grpSpPr>
          <a:xfrm>
            <a:off x="831742" y="1963838"/>
            <a:ext cx="3789519" cy="2199477"/>
            <a:chOff x="831742" y="1963838"/>
            <a:chExt cx="3789519" cy="2199477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B46736F-4ED6-475D-81E7-3951A3D7796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08937" y="1963838"/>
              <a:ext cx="3372158" cy="2198153"/>
            </a:xfrm>
            <a:prstGeom prst="rect">
              <a:avLst/>
            </a:prstGeom>
          </p:spPr>
        </p:pic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2FBC5186-9891-474A-9BEA-7FAE0257B938}"/>
                </a:ext>
              </a:extLst>
            </p:cNvPr>
            <p:cNvCxnSpPr/>
            <p:nvPr/>
          </p:nvCxnSpPr>
          <p:spPr>
            <a:xfrm>
              <a:off x="4402513" y="3714087"/>
              <a:ext cx="218748" cy="0"/>
            </a:xfrm>
            <a:prstGeom prst="line">
              <a:avLst/>
            </a:prstGeom>
            <a:ln w="28575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92FEC33B-D85B-42A9-8B41-13A417A2A8F0}"/>
                </a:ext>
              </a:extLst>
            </p:cNvPr>
            <p:cNvCxnSpPr>
              <a:cxnSpLocks/>
            </p:cNvCxnSpPr>
            <p:nvPr/>
          </p:nvCxnSpPr>
          <p:spPr>
            <a:xfrm>
              <a:off x="831742" y="2068464"/>
              <a:ext cx="15327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2625C1B4-BE06-4AA8-9009-A22CA63094C3}"/>
                </a:ext>
              </a:extLst>
            </p:cNvPr>
            <p:cNvCxnSpPr>
              <a:cxnSpLocks/>
            </p:cNvCxnSpPr>
            <p:nvPr/>
          </p:nvCxnSpPr>
          <p:spPr>
            <a:xfrm>
              <a:off x="833998" y="2437435"/>
              <a:ext cx="15327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1D794861-B32A-4AE1-A73B-E9A798D4D736}"/>
                </a:ext>
              </a:extLst>
            </p:cNvPr>
            <p:cNvCxnSpPr>
              <a:cxnSpLocks/>
            </p:cNvCxnSpPr>
            <p:nvPr/>
          </p:nvCxnSpPr>
          <p:spPr>
            <a:xfrm>
              <a:off x="836935" y="2798786"/>
              <a:ext cx="15327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AD4B958A-AB97-4720-A7BE-EAD5D42A35C5}"/>
                </a:ext>
              </a:extLst>
            </p:cNvPr>
            <p:cNvCxnSpPr>
              <a:cxnSpLocks/>
            </p:cNvCxnSpPr>
            <p:nvPr/>
          </p:nvCxnSpPr>
          <p:spPr>
            <a:xfrm>
              <a:off x="833998" y="3087747"/>
              <a:ext cx="15327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66D66A21-34A9-473C-B1BB-71A86484B766}"/>
                </a:ext>
              </a:extLst>
            </p:cNvPr>
            <p:cNvCxnSpPr>
              <a:cxnSpLocks/>
            </p:cNvCxnSpPr>
            <p:nvPr/>
          </p:nvCxnSpPr>
          <p:spPr>
            <a:xfrm>
              <a:off x="836935" y="3491008"/>
              <a:ext cx="15327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684F9EB5-883F-41D5-9779-B5B0AE298FC1}"/>
                </a:ext>
              </a:extLst>
            </p:cNvPr>
            <p:cNvSpPr/>
            <p:nvPr/>
          </p:nvSpPr>
          <p:spPr>
            <a:xfrm>
              <a:off x="999322" y="1968582"/>
              <a:ext cx="3384464" cy="2194733"/>
            </a:xfrm>
            <a:prstGeom prst="rect">
              <a:avLst/>
            </a:prstGeom>
            <a:noFill/>
            <a:ln w="571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141014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4</TotalTime>
  <Words>136</Words>
  <Application>Microsoft Office PowerPoint</Application>
  <PresentationFormat>Custom</PresentationFormat>
  <Paragraphs>7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Stephens</dc:creator>
  <cp:lastModifiedBy>Edward Stephens</cp:lastModifiedBy>
  <cp:revision>12</cp:revision>
  <cp:lastPrinted>2018-12-12T17:14:47Z</cp:lastPrinted>
  <dcterms:created xsi:type="dcterms:W3CDTF">2018-12-10T20:49:49Z</dcterms:created>
  <dcterms:modified xsi:type="dcterms:W3CDTF">2019-02-28T16:06:41Z</dcterms:modified>
</cp:coreProperties>
</file>